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B13149-E12D-4657-9D67-3B1F5491AE8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453B4E-ADCC-4282-B5D2-A0AEDFD6D0A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A27F9E-8B07-4BAA-8772-DFD1C07CE0F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64AACB-3C13-4376-B343-996F300108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465590-8DE7-4C0F-B2AE-276FBB2045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702E0-2445-4A65-B206-EEFA1E549B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1B83CC-A9CA-41BB-879E-F97F555DD2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B60C80-7B6A-4F68-9E88-8E89821106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6477E-4751-4E0E-BCF7-9AC9453DAC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BACEDC-078C-4173-AEAA-7464886244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905C0-CDB5-4CFF-93A5-3B4809BC4F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94353-6CE3-4391-8DA5-8209F89A6C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7A6DB-B6C5-43A8-9999-3D3060616D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885157-4F2E-4A5F-8377-0D45B4C237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F8488B-7646-4D5A-A71E-1619EEB0FCA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Additional fil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: Real-time PCR analysis of the ratio of miR-30a*/miR-214 in mice heart and  VEGF and EDEM mRNA in siRNA-XBP1treated H9C2 cells and representative immunostaining of CD31 in hearts are presented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1143000" y="1122480"/>
            <a:ext cx="6858000" cy="23875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MicroRNA regulation of unfolded protein response transcription factor XBP1 in the progression of cardiac hypertrophy and heart failure in vivo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 type="subTitle"/>
          </p:nvPr>
        </p:nvSpPr>
        <p:spPr>
          <a:xfrm>
            <a:off x="1143000" y="3601800"/>
            <a:ext cx="6858000" cy="1655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ctr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upplement dat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Rectangle 5"/>
          <p:cNvSpPr/>
          <p:nvPr/>
        </p:nvSpPr>
        <p:spPr>
          <a:xfrm>
            <a:off x="70920" y="15228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4"/>
          <p:cNvSpPr/>
          <p:nvPr/>
        </p:nvSpPr>
        <p:spPr>
          <a:xfrm>
            <a:off x="747720" y="14209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5"/>
          <p:cNvSpPr/>
          <p:nvPr/>
        </p:nvSpPr>
        <p:spPr>
          <a:xfrm>
            <a:off x="4879440" y="14209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6"/>
          <p:cNvSpPr/>
          <p:nvPr/>
        </p:nvSpPr>
        <p:spPr>
          <a:xfrm>
            <a:off x="1052640" y="4648320"/>
            <a:ext cx="70866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.S1 A time-course change in the ratio of miR-30a*/miR-214   during cardiac hypertrophy and heart failur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9" descr=""/>
          <p:cNvPicPr/>
          <p:nvPr/>
        </p:nvPicPr>
        <p:blipFill>
          <a:blip r:embed="rId1"/>
          <a:stretch/>
        </p:blipFill>
        <p:spPr>
          <a:xfrm>
            <a:off x="1295280" y="1752480"/>
            <a:ext cx="3248280" cy="215280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0" descr=""/>
          <p:cNvPicPr/>
          <p:nvPr/>
        </p:nvPicPr>
        <p:blipFill>
          <a:blip r:embed="rId2"/>
          <a:stretch/>
        </p:blipFill>
        <p:spPr>
          <a:xfrm>
            <a:off x="5334120" y="1905120"/>
            <a:ext cx="3295440" cy="2190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Rectangle 11"/>
          <p:cNvSpPr/>
          <p:nvPr/>
        </p:nvSpPr>
        <p:spPr>
          <a:xfrm>
            <a:off x="70920" y="15228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"/>
          <p:cNvSpPr/>
          <p:nvPr/>
        </p:nvSpPr>
        <p:spPr>
          <a:xfrm>
            <a:off x="2133720" y="4419720"/>
            <a:ext cx="60195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.S2 Real-time PCR analysis of VEGF and EDEM mRNA in H9C2 (2-1) cells transfected without siRNA XBP1 (100 nM). n =3. *P &lt; 0.05 compared with contro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6" descr=""/>
          <p:cNvPicPr/>
          <p:nvPr/>
        </p:nvPicPr>
        <p:blipFill>
          <a:blip r:embed="rId1"/>
          <a:stretch/>
        </p:blipFill>
        <p:spPr>
          <a:xfrm>
            <a:off x="3200400" y="2057400"/>
            <a:ext cx="2943360" cy="2000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Rectangle 5"/>
          <p:cNvSpPr/>
          <p:nvPr/>
        </p:nvSpPr>
        <p:spPr>
          <a:xfrm>
            <a:off x="70920" y="15228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1"/>
          <p:cNvSpPr/>
          <p:nvPr/>
        </p:nvSpPr>
        <p:spPr>
          <a:xfrm>
            <a:off x="1006560" y="5410080"/>
            <a:ext cx="7086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.S3 Representative immunostaining of CD31 in hearts after AA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Picture 8" descr=""/>
          <p:cNvPicPr/>
          <p:nvPr/>
        </p:nvPicPr>
        <p:blipFill>
          <a:blip r:embed="rId1"/>
          <a:stretch/>
        </p:blipFill>
        <p:spPr>
          <a:xfrm>
            <a:off x="4633920" y="3409920"/>
            <a:ext cx="2428920" cy="182880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9" descr=""/>
          <p:cNvPicPr/>
          <p:nvPr/>
        </p:nvPicPr>
        <p:blipFill>
          <a:blip r:embed="rId2"/>
          <a:stretch/>
        </p:blipFill>
        <p:spPr>
          <a:xfrm>
            <a:off x="2057400" y="3409920"/>
            <a:ext cx="2428920" cy="182880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11" descr=""/>
          <p:cNvPicPr/>
          <p:nvPr/>
        </p:nvPicPr>
        <p:blipFill>
          <a:blip r:embed="rId3"/>
          <a:stretch/>
        </p:blipFill>
        <p:spPr>
          <a:xfrm>
            <a:off x="4633920" y="1289160"/>
            <a:ext cx="2428920" cy="1828800"/>
          </a:xfrm>
          <a:prstGeom prst="rect">
            <a:avLst/>
          </a:prstGeom>
          <a:ln w="0">
            <a:noFill/>
          </a:ln>
        </p:spPr>
      </p:pic>
      <p:sp>
        <p:nvSpPr>
          <p:cNvPr id="66" name="TextBox 2"/>
          <p:cNvSpPr/>
          <p:nvPr/>
        </p:nvSpPr>
        <p:spPr>
          <a:xfrm>
            <a:off x="3137400" y="93996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ha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3"/>
          <p:cNvSpPr/>
          <p:nvPr/>
        </p:nvSpPr>
        <p:spPr>
          <a:xfrm>
            <a:off x="5246280" y="92556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AC1W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14"/>
          <p:cNvSpPr/>
          <p:nvPr/>
        </p:nvSpPr>
        <p:spPr>
          <a:xfrm>
            <a:off x="2920680" y="312120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AC4W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"/>
          <p:cNvSpPr/>
          <p:nvPr/>
        </p:nvSpPr>
        <p:spPr>
          <a:xfrm>
            <a:off x="5297760" y="311148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AC8W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Picture 12" descr=""/>
          <p:cNvPicPr/>
          <p:nvPr/>
        </p:nvPicPr>
        <p:blipFill>
          <a:blip r:embed="rId4"/>
          <a:stretch/>
        </p:blipFill>
        <p:spPr>
          <a:xfrm>
            <a:off x="2057400" y="1295280"/>
            <a:ext cx="2428920" cy="1828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QDuan</dc:creator>
  <dc:description/>
  <dc:language>en-US</dc:language>
  <cp:lastModifiedBy>QDuan</cp:lastModifiedBy>
  <dcterms:modified xsi:type="dcterms:W3CDTF">2015-11-12T16:06:22Z</dcterms:modified>
  <cp:revision>447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